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180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09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8614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18435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5742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102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7488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1207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05785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9590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9576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8308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415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D6444-29F3-47F6-A7C5-51F850E32F7C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09/10/2019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D9A6E-951D-40FC-84BF-D4985525FD4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19394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/>
          <p:cNvSpPr txBox="1"/>
          <p:nvPr/>
        </p:nvSpPr>
        <p:spPr>
          <a:xfrm>
            <a:off x="0" y="0"/>
            <a:ext cx="1675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.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Tableau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0917485"/>
              </p:ext>
            </p:extLst>
          </p:nvPr>
        </p:nvGraphicFramePr>
        <p:xfrm>
          <a:off x="2925509" y="801412"/>
          <a:ext cx="6500502" cy="5216988"/>
        </p:xfrm>
        <a:graphic>
          <a:graphicData uri="http://schemas.openxmlformats.org/drawingml/2006/table">
            <a:tbl>
              <a:tblPr/>
              <a:tblGrid>
                <a:gridCol w="7222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2278">
                  <a:extLst>
                    <a:ext uri="{9D8B030D-6E8A-4147-A177-3AD203B41FA5}">
                      <a16:colId xmlns:a16="http://schemas.microsoft.com/office/drawing/2014/main" val="413344100"/>
                    </a:ext>
                  </a:extLst>
                </a:gridCol>
                <a:gridCol w="722278">
                  <a:extLst>
                    <a:ext uri="{9D8B030D-6E8A-4147-A177-3AD203B41FA5}">
                      <a16:colId xmlns:a16="http://schemas.microsoft.com/office/drawing/2014/main" val="3673700714"/>
                    </a:ext>
                  </a:extLst>
                </a:gridCol>
                <a:gridCol w="722278">
                  <a:extLst>
                    <a:ext uri="{9D8B030D-6E8A-4147-A177-3AD203B41FA5}">
                      <a16:colId xmlns:a16="http://schemas.microsoft.com/office/drawing/2014/main" val="3791327586"/>
                    </a:ext>
                  </a:extLst>
                </a:gridCol>
                <a:gridCol w="722278">
                  <a:extLst>
                    <a:ext uri="{9D8B030D-6E8A-4147-A177-3AD203B41FA5}">
                      <a16:colId xmlns:a16="http://schemas.microsoft.com/office/drawing/2014/main" val="3330471256"/>
                    </a:ext>
                  </a:extLst>
                </a:gridCol>
                <a:gridCol w="722278">
                  <a:extLst>
                    <a:ext uri="{9D8B030D-6E8A-4147-A177-3AD203B41FA5}">
                      <a16:colId xmlns:a16="http://schemas.microsoft.com/office/drawing/2014/main" val="4200704021"/>
                    </a:ext>
                  </a:extLst>
                </a:gridCol>
                <a:gridCol w="722278">
                  <a:extLst>
                    <a:ext uri="{9D8B030D-6E8A-4147-A177-3AD203B41FA5}">
                      <a16:colId xmlns:a16="http://schemas.microsoft.com/office/drawing/2014/main" val="1435266965"/>
                    </a:ext>
                  </a:extLst>
                </a:gridCol>
                <a:gridCol w="722278">
                  <a:extLst>
                    <a:ext uri="{9D8B030D-6E8A-4147-A177-3AD203B41FA5}">
                      <a16:colId xmlns:a16="http://schemas.microsoft.com/office/drawing/2014/main" val="274068637"/>
                    </a:ext>
                  </a:extLst>
                </a:gridCol>
                <a:gridCol w="722278">
                  <a:extLst>
                    <a:ext uri="{9D8B030D-6E8A-4147-A177-3AD203B41FA5}">
                      <a16:colId xmlns:a16="http://schemas.microsoft.com/office/drawing/2014/main" val="674834788"/>
                    </a:ext>
                  </a:extLst>
                </a:gridCol>
              </a:tblGrid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Quartile 1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Quartile 2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Quartile 3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Quartile 4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4925098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err="1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miR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err="1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Mean</a:t>
                      </a: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D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err="1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Mean</a:t>
                      </a: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D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err="1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Mean</a:t>
                      </a: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D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err="1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Mean</a:t>
                      </a: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1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D</a:t>
                      </a:r>
                      <a:endParaRPr lang="fr-FR" sz="12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26-3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6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5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7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29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739.1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8268.5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32-3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7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4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6.8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6.0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39-5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7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6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5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6.5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5.0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46a-5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53</a:t>
                      </a:r>
                      <a:endParaRPr lang="fr-FR" sz="1200" b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1</a:t>
                      </a:r>
                      <a:endParaRPr lang="fr-FR" sz="1200" b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0</a:t>
                      </a:r>
                      <a:endParaRPr lang="fr-FR" sz="1200" b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6</a:t>
                      </a:r>
                      <a:endParaRPr lang="fr-FR" sz="1200" b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5</a:t>
                      </a:r>
                      <a:endParaRPr lang="fr-FR" sz="1200" b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0</a:t>
                      </a:r>
                      <a:endParaRPr lang="fr-FR" sz="1200" b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95</a:t>
                      </a:r>
                      <a:endParaRPr lang="fr-FR" sz="1200" b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b="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41</a:t>
                      </a:r>
                      <a:endParaRPr lang="fr-FR" sz="1200" b="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6-5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5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7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6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6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8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3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0.3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1.2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86-5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6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7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9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6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95-5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5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7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4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5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99a-3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6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2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0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00a-3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4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7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6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9a-3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5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2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3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2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9b-3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4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3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1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9c-3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4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1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9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7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45-5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6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4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.9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4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6.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3.9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7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34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4.5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5.6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885-5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5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8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99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.2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93-5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5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8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0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.2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1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842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let-7e-5p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1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9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8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2.43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72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4.56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fr-FR" sz="12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16.70</a:t>
                      </a:r>
                      <a:endParaRPr lang="fr-FR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206237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192</Words>
  <Application>Microsoft Office PowerPoint</Application>
  <PresentationFormat>Grand écran</PresentationFormat>
  <Paragraphs>18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C</dc:creator>
  <cp:lastModifiedBy>JC</cp:lastModifiedBy>
  <cp:revision>20</cp:revision>
  <dcterms:created xsi:type="dcterms:W3CDTF">2019-03-07T12:50:28Z</dcterms:created>
  <dcterms:modified xsi:type="dcterms:W3CDTF">2019-10-09T14:33:03Z</dcterms:modified>
</cp:coreProperties>
</file>